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iall Waterbright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352" autoAdjust="0"/>
    <p:restoredTop sz="94524" autoAdjust="0"/>
  </p:normalViewPr>
  <p:slideViewPr>
    <p:cSldViewPr snapToGrid="0">
      <p:cViewPr>
        <p:scale>
          <a:sx n="70" d="100"/>
          <a:sy n="70" d="100"/>
        </p:scale>
        <p:origin x="-2946" y="-372"/>
      </p:cViewPr>
      <p:guideLst>
        <p:guide orient="horz" pos="2880"/>
        <p:guide pos="37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CA27994D-EA07-4540-B8FB-E1340A7146B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16463"/>
            <a:ext cx="5440363" cy="4468812"/>
          </a:xfrm>
          <a:prstGeom prst="rect">
            <a:avLst/>
          </a:prstGeom>
        </p:spPr>
        <p:txBody>
          <a:bodyPr vert="horz" lIns="91435" tIns="45717" rIns="91435" bIns="4571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9"/>
            <a:ext cx="2946400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D4FE59A2-6B6F-470E-9075-FD9A46E9EC4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896356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4FE59A2-6B6F-470E-9075-FD9A46E9EC4C}" type="slidenum">
              <a:rPr lang="en-AU" smtClean="0"/>
              <a:pPr/>
              <a:t>1</a:t>
            </a:fld>
            <a:endParaRPr lang="en-A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74843-345F-4BE4-A90A-D6624012AEAD}" type="datetimeFigureOut">
              <a:rPr lang="en-AU" smtClean="0"/>
              <a:pPr/>
              <a:t>5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751DA-B0CE-4299-9A05-3B1A0F4A3B86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/>
          <p:cNvSpPr txBox="1">
            <a:spLocks/>
          </p:cNvSpPr>
          <p:nvPr/>
        </p:nvSpPr>
        <p:spPr>
          <a:xfrm>
            <a:off x="1196752" y="1763688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A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0" name="Title 1"/>
          <p:cNvSpPr txBox="1">
            <a:spLocks/>
          </p:cNvSpPr>
          <p:nvPr/>
        </p:nvSpPr>
        <p:spPr>
          <a:xfrm>
            <a:off x="1196752" y="3419872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C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2" name="Title 1"/>
          <p:cNvSpPr txBox="1">
            <a:spLocks/>
          </p:cNvSpPr>
          <p:nvPr/>
        </p:nvSpPr>
        <p:spPr>
          <a:xfrm>
            <a:off x="1484784" y="4067944"/>
            <a:ext cx="3888432" cy="1872208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3 Fig</a:t>
            </a:r>
            <a:r>
              <a:rPr lang="en-US" sz="1200" b="1" noProof="0" dirty="0" smtClean="0">
                <a:latin typeface="Arial" pitchFamily="34" charset="0"/>
                <a:cs typeface="Arial" pitchFamily="34" charset="0"/>
              </a:rPr>
              <a:t>. eEF1A can co-immunoprecipitate with RT.</a:t>
            </a:r>
            <a:r>
              <a:rPr lang="en-US" sz="1200" noProof="0" dirty="0" smtClean="0">
                <a:latin typeface="Arial" pitchFamily="34" charset="0"/>
                <a:cs typeface="Arial" pitchFamily="34" charset="0"/>
              </a:rPr>
              <a:t> </a:t>
            </a:r>
            <a:endParaRPr kumimoji="0" lang="en-AU" sz="1200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1988840" y="1475656"/>
            <a:ext cx="1277083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ell </a:t>
            </a:r>
            <a:r>
              <a:rPr lang="en-AU" sz="10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lysate</a:t>
            </a:r>
            <a:endParaRPr lang="en-AU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3356992" y="3491880"/>
            <a:ext cx="1821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/>
          <p:cNvSpPr/>
          <p:nvPr/>
        </p:nvSpPr>
        <p:spPr>
          <a:xfrm>
            <a:off x="3501008" y="3347864"/>
            <a:ext cx="620540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55 </a:t>
            </a:r>
            <a:r>
              <a:rPr lang="en-AU" sz="9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D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60848" y="2627784"/>
            <a:ext cx="1296144" cy="5760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221088" y="1907704"/>
            <a:ext cx="1224136" cy="5760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221088" y="2627784"/>
            <a:ext cx="1224136" cy="5722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4221088" y="3347864"/>
            <a:ext cx="1224136" cy="5357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060848" y="3347864"/>
            <a:ext cx="1296144" cy="5121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060848" y="1907704"/>
            <a:ext cx="1296144" cy="5760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3" name="Rectangle 42"/>
          <p:cNvSpPr/>
          <p:nvPr/>
        </p:nvSpPr>
        <p:spPr>
          <a:xfrm>
            <a:off x="4149080" y="1475656"/>
            <a:ext cx="1277083" cy="2160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0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nti-RT IP product</a:t>
            </a:r>
            <a:endParaRPr lang="en-AU" sz="10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4077072" y="2915816"/>
            <a:ext cx="1821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356992" y="2051720"/>
            <a:ext cx="1821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4077072" y="2051720"/>
            <a:ext cx="1821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4077072" y="3491880"/>
            <a:ext cx="1821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3356992" y="2915816"/>
            <a:ext cx="18213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ectangle 51"/>
          <p:cNvSpPr/>
          <p:nvPr/>
        </p:nvSpPr>
        <p:spPr>
          <a:xfrm>
            <a:off x="3501008" y="1907704"/>
            <a:ext cx="620540" cy="3600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55 </a:t>
            </a:r>
            <a:r>
              <a:rPr lang="en-AU" sz="9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D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3501008" y="2771800"/>
            <a:ext cx="620540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170 </a:t>
            </a:r>
            <a:r>
              <a:rPr lang="en-AU" sz="900" dirty="0" err="1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kD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980728" y="2051720"/>
            <a:ext cx="1008112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B Anti-eEF1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980728" y="2843808"/>
            <a:ext cx="1008112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B Anti-eIF3A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908720" y="3635896"/>
            <a:ext cx="1080120" cy="28803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900" dirty="0" smtClean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B Anti-HIV RT</a:t>
            </a:r>
            <a:endParaRPr lang="en-AU" sz="900" dirty="0">
              <a:solidFill>
                <a:schemeClr val="tx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itle 1"/>
          <p:cNvSpPr txBox="1">
            <a:spLocks/>
          </p:cNvSpPr>
          <p:nvPr/>
        </p:nvSpPr>
        <p:spPr>
          <a:xfrm>
            <a:off x="1196752" y="2699792"/>
            <a:ext cx="288032" cy="21602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lvl="0">
              <a:spcBef>
                <a:spcPct val="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B</a:t>
            </a:r>
            <a:endParaRPr kumimoji="0" lang="en-AU" sz="1200" b="1" i="0" u="none" strike="noStrike" kern="1200" cap="none" spc="0" normalizeH="0" baseline="0" noProof="0" dirty="0">
              <a:ln>
                <a:noFill/>
              </a:ln>
              <a:solidFill>
                <a:schemeClr val="tx1">
                  <a:lumMod val="85000"/>
                  <a:lumOff val="15000"/>
                </a:schemeClr>
              </a:solidFill>
              <a:effectLst/>
              <a:uLnTx/>
              <a:uFillTx/>
              <a:latin typeface="Arial" pitchFamily="34" charset="0"/>
              <a:ea typeface="+mj-ea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2</TotalTime>
  <Words>31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Queensland Institute of Medical 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ongsheL</dc:creator>
  <cp:lastModifiedBy>dongshel</cp:lastModifiedBy>
  <cp:revision>519</cp:revision>
  <dcterms:created xsi:type="dcterms:W3CDTF">2014-03-06T01:01:54Z</dcterms:created>
  <dcterms:modified xsi:type="dcterms:W3CDTF">2015-11-04T23:31:14Z</dcterms:modified>
</cp:coreProperties>
</file>